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3B95B8-AA78-4486-8228-0967A09B203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DAB6E8-54DE-4A10-A81E-F0AAACD73E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55AA36-106D-4B93-9237-06B7554CB8F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86D8F3-8295-4D4E-8241-46986BC5316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43A593-8634-4E7F-AADD-2C0840BFAD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0A0BCA-F065-48FD-8707-582C1BAD7E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93BF3A-4041-4863-9DBA-5D2916564B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E3C06D-C316-476A-8D62-0D720E7F34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4232E4-19EB-4956-A9CC-BD7C112BFF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5702B9-6A1E-4C5C-BA55-5EAFF1D885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ACF712-DE86-4823-8D54-61DACFA9A8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878D7D-4BD5-40FC-959A-EAFD3AC7E6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E3795DB-CE68-4103-A87B-B53A6EE6E57B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041480" y="1927080"/>
            <a:ext cx="5207040" cy="3443400"/>
            <a:chOff x="1041480" y="1927080"/>
            <a:chExt cx="5207040" cy="3443400"/>
          </a:xfrm>
        </p:grpSpPr>
        <p:sp>
          <p:nvSpPr>
            <p:cNvPr id="42" name=""/>
            <p:cNvSpPr/>
            <p:nvPr/>
          </p:nvSpPr>
          <p:spPr>
            <a:xfrm>
              <a:off x="4098960" y="4971960"/>
              <a:ext cx="21495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** p&lt;0.01 POKO </a:t>
              </a:r>
              <a:r>
                <a:rPr b="0" i="1" lang="en-GB" sz="1000" spc="-1" strike="noStrike">
                  <a:solidFill>
                    <a:srgbClr val="000000"/>
                  </a:solidFill>
                  <a:latin typeface="Arial"/>
                </a:rPr>
                <a:t>vs. 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### p&lt;0.001 POKO </a:t>
              </a:r>
              <a:r>
                <a:rPr b="0" i="1" lang="en-GB" sz="1000" spc="-1" strike="noStrike">
                  <a:solidFill>
                    <a:srgbClr val="000000"/>
                  </a:solidFill>
                  <a:latin typeface="Arial"/>
                </a:rPr>
                <a:t>vs.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 ob/o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3308760" y="192708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ale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444760" y="2422440"/>
              <a:ext cx="19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3295440" y="2422440"/>
              <a:ext cx="34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ob/o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024080" y="2422440"/>
              <a:ext cx="718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PAR</a:t>
              </a:r>
              <a:r>
                <a:rPr b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 KO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5251680" y="2422440"/>
              <a:ext cx="374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OKO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238400" y="2422440"/>
              <a:ext cx="634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(mg/g BW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429200" y="2752560"/>
              <a:ext cx="302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Liver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280600" y="2752560"/>
              <a:ext cx="49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8.8±1.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195000" y="2752560"/>
              <a:ext cx="561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1.71±2.7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185720" y="2752560"/>
              <a:ext cx="49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4.8±0.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138280" y="2752560"/>
              <a:ext cx="49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3.0±6.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1453680" y="2917800"/>
              <a:ext cx="26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A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318040" y="2917800"/>
              <a:ext cx="421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.8±0.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3270600" y="2917800"/>
              <a:ext cx="421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.2±0.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4223160" y="2917800"/>
              <a:ext cx="421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.4±0.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5175720" y="2917800"/>
              <a:ext cx="421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.2±0.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441440" y="3083040"/>
              <a:ext cx="28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WA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280600" y="3083040"/>
              <a:ext cx="49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9.8±3.9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233160" y="3083040"/>
              <a:ext cx="49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1.0±5.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4185720" y="3083040"/>
              <a:ext cx="49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4.2±4.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5175720" y="3083040"/>
              <a:ext cx="421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.7±0.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104840" y="2225520"/>
              <a:ext cx="47624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104840" y="2556000"/>
              <a:ext cx="47624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5574240" y="2982960"/>
              <a:ext cx="278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5523120" y="3057480"/>
              <a:ext cx="34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###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5533920" y="3235320"/>
              <a:ext cx="184320" cy="21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3156840" y="3406680"/>
              <a:ext cx="50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emale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2381040" y="3902040"/>
              <a:ext cx="19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232080" y="3902040"/>
              <a:ext cx="34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ob/o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960360" y="3902040"/>
              <a:ext cx="718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PAR</a:t>
              </a:r>
              <a:r>
                <a:rPr b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 KO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5188320" y="3902040"/>
              <a:ext cx="374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OKO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1174680" y="4067280"/>
              <a:ext cx="360" cy="36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1365480" y="4232160"/>
              <a:ext cx="302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Liver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217240" y="4232160"/>
              <a:ext cx="49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7.6±8.9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169800" y="4232160"/>
              <a:ext cx="49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0.7±5.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4122360" y="4232160"/>
              <a:ext cx="49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0.5±1.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5074560" y="4232160"/>
              <a:ext cx="49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8.9±1.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1390320" y="4397400"/>
              <a:ext cx="26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A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254680" y="4397400"/>
              <a:ext cx="421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.5±0.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3207240" y="4397400"/>
              <a:ext cx="421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.5±0.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4159440" y="4397400"/>
              <a:ext cx="421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.5±0.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5112000" y="4397400"/>
              <a:ext cx="421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.6±1.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378080" y="4562640"/>
              <a:ext cx="28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WA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217240" y="4562640"/>
              <a:ext cx="49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8.7±6.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169800" y="4562640"/>
              <a:ext cx="49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3.2±2.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4122360" y="4562640"/>
              <a:ext cx="49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2.3±1.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5074560" y="4562640"/>
              <a:ext cx="49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7.6±3.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041480" y="3705120"/>
              <a:ext cx="47624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041480" y="4035600"/>
              <a:ext cx="47624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5523120" y="4530600"/>
              <a:ext cx="34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###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5523120" y="4213080"/>
              <a:ext cx="34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###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4" name=""/>
          <p:cNvSpPr/>
          <p:nvPr/>
        </p:nvSpPr>
        <p:spPr>
          <a:xfrm>
            <a:off x="1080720" y="1165320"/>
            <a:ext cx="4615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Tissue weights of 16-wk-old male POKO, ob/ob, PPAR</a:t>
            </a:r>
            <a:r>
              <a:rPr b="1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2 KO and WT mic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4962600" y="5800680"/>
            <a:ext cx="18396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5563080" y="8112240"/>
            <a:ext cx="81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able S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1087920" y="3848040"/>
            <a:ext cx="814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(mg/g BW)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2-09T18:50:00Z</dcterms:created>
  <dc:creator>Antonio Vidal-Puig</dc:creator>
  <dc:description/>
  <dc:language>en-US</dc:language>
  <cp:lastModifiedBy>Antonio Vidal-Puig</cp:lastModifiedBy>
  <dcterms:modified xsi:type="dcterms:W3CDTF">2007-03-05T17:19:24Z</dcterms:modified>
  <cp:revision>69</cp:revision>
  <dc:subject/>
  <dc:title>PowerPoint Presentation</dc:title>
</cp:coreProperties>
</file>